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6762F-AC4F-4F3A-BEFA-9DB4081776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35014-81BA-460C-9C8B-117CF7FEE2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732A3-EA9D-48C2-94B5-CB787692D3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3F3DD-AC46-4BC7-BB47-E145B85A42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4D98B-4051-4FB0-96B9-0A9D60EDCE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B2863-9BC9-4B5D-98BE-2DB2B1F246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B2B5E-3E00-487D-ACFA-5F3B2970A7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14DD8-A515-4949-857F-9AFFC9E27C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800BC9-3033-445C-9423-F5EFAC9DFC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B96BF6-C015-4D80-A9C4-75CC1606D7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A9969-0FD1-458F-B776-56EAE16F84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1EFD9-3A0A-4DEA-9378-A0F869DCBF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BCD0EC-EDD4-4EF9-AB26-780C2993FC6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" descr=""/>
          <p:cNvPicPr/>
          <p:nvPr/>
        </p:nvPicPr>
        <p:blipFill>
          <a:blip r:embed="rId1"/>
          <a:stretch/>
        </p:blipFill>
        <p:spPr>
          <a:xfrm>
            <a:off x="914400" y="530280"/>
            <a:ext cx="7620120" cy="45781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2"/>
          <p:cNvSpPr/>
          <p:nvPr/>
        </p:nvSpPr>
        <p:spPr>
          <a:xfrm>
            <a:off x="1090440" y="5416560"/>
            <a:ext cx="70866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2. Classification of the predicted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. virguliforme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roteins based on GO annotation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Biological process was considered in classifying the gene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Bhattacharyya, Madan K [AGRON]</dc:creator>
  <dc:description/>
  <dc:language>en-US</dc:language>
  <cp:lastModifiedBy>Bhattacharyya, Madan K [AGRON]</cp:lastModifiedBy>
  <dcterms:modified xsi:type="dcterms:W3CDTF">2013-06-08T23:56:00Z</dcterms:modified>
  <cp:revision>16</cp:revision>
  <dc:subject/>
  <dc:title>Slide 1</dc:title>
</cp:coreProperties>
</file>